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ED4DC-2D23-4AFF-8C7C-B0065FD6A6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4960" y="601092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2A81A-17B9-453F-B1FD-059FE57B58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93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22F53-7E08-439E-9BA5-7AA12933F2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011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673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49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011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673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99B50-EDE6-4D38-9E2C-F839E91469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50"/>
              </a:spcBef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83BA7-7275-4654-A174-C5ED14284D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F78CE-28AE-4318-ADA2-0718BF9E33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504C60-8B7C-4D8B-A146-73E2A76F18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EA896-BE1D-468E-AA8E-BB82648248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4960" y="534960"/>
            <a:ext cx="6702480" cy="901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50"/>
              </a:spcBef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6EDDF-4152-43EE-90F8-A80539649F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54961-891D-4566-8CC1-2B97797D84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93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9F852-5FA8-46B8-A4A1-CB0E547DF2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4B4ED-9D8C-4B05-A14D-98CB51BBFC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9368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8248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7164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590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4600" y="9323280"/>
            <a:ext cx="174780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75080" y="9323280"/>
            <a:ext cx="262224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89280" y="9323280"/>
            <a:ext cx="174780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3049FF-E730-4D43-8538-4C088343DE0D}" type="slidenum">
              <a:rPr b="0" lang="en-US" sz="10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3758" t="5539" r="-223" b="6881"/>
          <a:stretch/>
        </p:blipFill>
        <p:spPr>
          <a:xfrm>
            <a:off x="701640" y="7932600"/>
            <a:ext cx="6851520" cy="1646280"/>
          </a:xfrm>
          <a:prstGeom prst="rect">
            <a:avLst/>
          </a:prstGeom>
          <a:ln w="0">
            <a:noFill/>
          </a:ln>
        </p:spPr>
      </p:pic>
      <p:sp>
        <p:nvSpPr>
          <p:cNvPr id="42" name="TextBox 6"/>
          <p:cNvSpPr/>
          <p:nvPr/>
        </p:nvSpPr>
        <p:spPr>
          <a:xfrm>
            <a:off x="4505400" y="61920"/>
            <a:ext cx="3267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8"/>
          <p:cNvSpPr/>
          <p:nvPr/>
        </p:nvSpPr>
        <p:spPr>
          <a:xfrm>
            <a:off x="136440" y="555480"/>
            <a:ext cx="333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54000" y="7732800"/>
            <a:ext cx="409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Group 1"/>
          <p:cNvGrpSpPr/>
          <p:nvPr/>
        </p:nvGrpSpPr>
        <p:grpSpPr>
          <a:xfrm>
            <a:off x="506520" y="7810200"/>
            <a:ext cx="6900840" cy="2085840"/>
            <a:chOff x="506520" y="7810200"/>
            <a:chExt cx="6900840" cy="2085840"/>
          </a:xfrm>
        </p:grpSpPr>
        <p:sp>
          <p:nvSpPr>
            <p:cNvPr id="46" name="TextBox 14"/>
            <p:cNvSpPr/>
            <p:nvPr/>
          </p:nvSpPr>
          <p:spPr>
            <a:xfrm rot="16200000">
              <a:off x="-111240" y="8427960"/>
              <a:ext cx="1467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simulated ser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5"/>
            <p:cNvSpPr/>
            <p:nvPr/>
          </p:nvSpPr>
          <p:spPr>
            <a:xfrm>
              <a:off x="1238400" y="9660240"/>
              <a:ext cx="104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ue positiv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Straight Connector 140"/>
            <p:cNvSpPr/>
            <p:nvPr/>
          </p:nvSpPr>
          <p:spPr>
            <a:xfrm flipV="1">
              <a:off x="1228680" y="9657000"/>
              <a:ext cx="98568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21"/>
            <p:cNvSpPr/>
            <p:nvPr/>
          </p:nvSpPr>
          <p:spPr>
            <a:xfrm>
              <a:off x="2687400" y="9657000"/>
              <a:ext cx="113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alse positiv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Straight Connector 144"/>
            <p:cNvSpPr/>
            <p:nvPr/>
          </p:nvSpPr>
          <p:spPr>
            <a:xfrm flipV="1">
              <a:off x="2678040" y="9657000"/>
              <a:ext cx="98568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5"/>
            <p:cNvSpPr/>
            <p:nvPr/>
          </p:nvSpPr>
          <p:spPr>
            <a:xfrm>
              <a:off x="4782960" y="9664920"/>
              <a:ext cx="104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ue positiv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Straight Connector 146"/>
            <p:cNvSpPr/>
            <p:nvPr/>
          </p:nvSpPr>
          <p:spPr>
            <a:xfrm flipV="1">
              <a:off x="4764240" y="9664920"/>
              <a:ext cx="98568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21"/>
            <p:cNvSpPr/>
            <p:nvPr/>
          </p:nvSpPr>
          <p:spPr>
            <a:xfrm>
              <a:off x="6275520" y="9657000"/>
              <a:ext cx="113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alse positiv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148"/>
            <p:cNvSpPr/>
            <p:nvPr/>
          </p:nvSpPr>
          <p:spPr>
            <a:xfrm flipV="1">
              <a:off x="6294600" y="9657000"/>
              <a:ext cx="98568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9"/>
            <p:cNvSpPr/>
            <p:nvPr/>
          </p:nvSpPr>
          <p:spPr>
            <a:xfrm>
              <a:off x="1895400" y="8020080"/>
              <a:ext cx="1085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-strain panel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30"/>
            <p:cNvSpPr/>
            <p:nvPr/>
          </p:nvSpPr>
          <p:spPr>
            <a:xfrm>
              <a:off x="5450400" y="8021520"/>
              <a:ext cx="666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337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8"/>
          <p:cNvSpPr/>
          <p:nvPr/>
        </p:nvSpPr>
        <p:spPr>
          <a:xfrm>
            <a:off x="130320" y="4183200"/>
            <a:ext cx="333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1" descr=""/>
          <p:cNvPicPr/>
          <p:nvPr/>
        </p:nvPicPr>
        <p:blipFill>
          <a:blip r:embed="rId2"/>
          <a:srcRect l="0" t="4642" r="0" b="0"/>
          <a:stretch/>
        </p:blipFill>
        <p:spPr>
          <a:xfrm>
            <a:off x="506520" y="374760"/>
            <a:ext cx="6232320" cy="36576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3"/>
          <a:srcRect l="0" t="5124" r="0" b="0"/>
          <a:stretch/>
        </p:blipFill>
        <p:spPr>
          <a:xfrm>
            <a:off x="371520" y="4049640"/>
            <a:ext cx="5513400" cy="3657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2-18T15:01:00Z</dcterms:created>
  <dc:creator>iglab</dc:creator>
  <dc:description/>
  <dc:language>en-US</dc:language>
  <cp:lastModifiedBy>iglab</cp:lastModifiedBy>
  <dcterms:modified xsi:type="dcterms:W3CDTF">2021-12-03T04:01:17Z</dcterms:modified>
  <cp:revision>276</cp:revision>
  <dc:subject/>
  <dc:title>PowerPoint Presentation</dc:title>
</cp:coreProperties>
</file>